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76" r:id="rId2"/>
    <p:sldId id="263" r:id="rId3"/>
    <p:sldId id="274" r:id="rId4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56" userDrawn="1">
          <p15:clr>
            <a:srgbClr val="A4A3A4"/>
          </p15:clr>
        </p15:guide>
        <p15:guide id="2" pos="5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3366"/>
    <a:srgbClr val="0033CC"/>
    <a:srgbClr val="F5E4E3"/>
    <a:srgbClr val="FFF8E1"/>
    <a:srgbClr val="FFEDB3"/>
    <a:srgbClr val="E1F1FF"/>
    <a:srgbClr val="D9FFFF"/>
    <a:srgbClr val="E7E7FF"/>
    <a:srgbClr val="CCCCFF"/>
    <a:srgbClr val="A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648" autoAdjust="0"/>
    <p:restoredTop sz="93380" autoAdjust="0"/>
  </p:normalViewPr>
  <p:slideViewPr>
    <p:cSldViewPr>
      <p:cViewPr varScale="1">
        <p:scale>
          <a:sx n="86" d="100"/>
          <a:sy n="86" d="100"/>
        </p:scale>
        <p:origin x="2608" y="208"/>
      </p:cViewPr>
      <p:guideLst>
        <p:guide orient="horz" pos="3456"/>
        <p:guide pos="52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155" cy="46498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673" y="0"/>
            <a:ext cx="3038155" cy="46498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3C5741A-76FC-4297-973F-3518B63DA20A}" type="datetimeFigureOut">
              <a:rPr lang="en-US" smtClean="0"/>
              <a:t>6/1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829792"/>
            <a:ext cx="3038155" cy="46498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673" y="8829792"/>
            <a:ext cx="3038155" cy="46498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664F6FB-19C6-43E6-AACA-768D337347D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80497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155" cy="46498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673" y="0"/>
            <a:ext cx="3038155" cy="46498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4C6D86-BFF5-483A-9425-8105651A84FF}" type="datetimeFigureOut">
              <a:rPr lang="en-US" smtClean="0"/>
              <a:t>6/12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8688" y="696913"/>
            <a:ext cx="261302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355" y="4415709"/>
            <a:ext cx="5607691" cy="418321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792"/>
            <a:ext cx="3038155" cy="46498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673" y="8829792"/>
            <a:ext cx="3038155" cy="46498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606EF4-4442-45E8-BD7E-8B14F0816C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19364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F91BA-B91D-41A7-AD87-FB42DE68122F}" type="datetimeFigureOut">
              <a:rPr lang="en-US" smtClean="0"/>
              <a:t>6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2151E-722E-433F-8066-4ED3664EF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3371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F91BA-B91D-41A7-AD87-FB42DE68122F}" type="datetimeFigureOut">
              <a:rPr lang="en-US" smtClean="0"/>
              <a:t>6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2151E-722E-433F-8066-4ED3664EF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464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F91BA-B91D-41A7-AD87-FB42DE68122F}" type="datetimeFigureOut">
              <a:rPr lang="en-US" smtClean="0"/>
              <a:t>6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2151E-722E-433F-8066-4ED3664EF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652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F91BA-B91D-41A7-AD87-FB42DE68122F}" type="datetimeFigureOut">
              <a:rPr lang="en-US" smtClean="0"/>
              <a:t>6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2151E-722E-433F-8066-4ED3664EF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206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F91BA-B91D-41A7-AD87-FB42DE68122F}" type="datetimeFigureOut">
              <a:rPr lang="en-US" smtClean="0"/>
              <a:t>6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2151E-722E-433F-8066-4ED3664EF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3613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F91BA-B91D-41A7-AD87-FB42DE68122F}" type="datetimeFigureOut">
              <a:rPr lang="en-US" smtClean="0"/>
              <a:t>6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2151E-722E-433F-8066-4ED3664EF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82894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F91BA-B91D-41A7-AD87-FB42DE68122F}" type="datetimeFigureOut">
              <a:rPr lang="en-US" smtClean="0"/>
              <a:t>6/1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2151E-722E-433F-8066-4ED3664EF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54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F91BA-B91D-41A7-AD87-FB42DE68122F}" type="datetimeFigureOut">
              <a:rPr lang="en-US" smtClean="0"/>
              <a:t>6/1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2151E-722E-433F-8066-4ED3664EF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1906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F91BA-B91D-41A7-AD87-FB42DE68122F}" type="datetimeFigureOut">
              <a:rPr lang="en-US" smtClean="0"/>
              <a:t>6/1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2151E-722E-433F-8066-4ED3664EF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50045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F91BA-B91D-41A7-AD87-FB42DE68122F}" type="datetimeFigureOut">
              <a:rPr lang="en-US" smtClean="0"/>
              <a:t>6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2151E-722E-433F-8066-4ED3664EF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4207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FF91BA-B91D-41A7-AD87-FB42DE68122F}" type="datetimeFigureOut">
              <a:rPr lang="en-US" smtClean="0"/>
              <a:t>6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D2151E-722E-433F-8066-4ED3664EF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8738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FF91BA-B91D-41A7-AD87-FB42DE68122F}" type="datetimeFigureOut">
              <a:rPr lang="en-US" smtClean="0"/>
              <a:t>6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D2151E-722E-433F-8066-4ED3664EF05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462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tiff"/><Relationship Id="rId2" Type="http://schemas.openxmlformats.org/officeDocument/2006/relationships/image" Target="../media/image1.emf"/><Relationship Id="rId16" Type="http://schemas.openxmlformats.org/officeDocument/2006/relationships/image" Target="../media/image1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tif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13" Type="http://schemas.openxmlformats.org/officeDocument/2006/relationships/image" Target="../media/image28.tiff"/><Relationship Id="rId3" Type="http://schemas.openxmlformats.org/officeDocument/2006/relationships/image" Target="../media/image18.png"/><Relationship Id="rId7" Type="http://schemas.openxmlformats.org/officeDocument/2006/relationships/image" Target="../media/image22.emf"/><Relationship Id="rId12" Type="http://schemas.openxmlformats.org/officeDocument/2006/relationships/image" Target="../media/image27.emf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emf"/><Relationship Id="rId11" Type="http://schemas.openxmlformats.org/officeDocument/2006/relationships/image" Target="../media/image26.emf"/><Relationship Id="rId5" Type="http://schemas.openxmlformats.org/officeDocument/2006/relationships/image" Target="../media/image20.png"/><Relationship Id="rId10" Type="http://schemas.openxmlformats.org/officeDocument/2006/relationships/image" Target="../media/image25.emf"/><Relationship Id="rId4" Type="http://schemas.openxmlformats.org/officeDocument/2006/relationships/image" Target="../media/image19.png"/><Relationship Id="rId9" Type="http://schemas.openxmlformats.org/officeDocument/2006/relationships/image" Target="../media/image24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tiff"/><Relationship Id="rId3" Type="http://schemas.openxmlformats.org/officeDocument/2006/relationships/image" Target="../media/image30.emf"/><Relationship Id="rId7" Type="http://schemas.openxmlformats.org/officeDocument/2006/relationships/image" Target="../media/image34.emf"/><Relationship Id="rId12" Type="http://schemas.openxmlformats.org/officeDocument/2006/relationships/image" Target="../media/image39.png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3.emf"/><Relationship Id="rId11" Type="http://schemas.openxmlformats.org/officeDocument/2006/relationships/image" Target="../media/image38.png"/><Relationship Id="rId5" Type="http://schemas.openxmlformats.org/officeDocument/2006/relationships/image" Target="../media/image32.emf"/><Relationship Id="rId10" Type="http://schemas.openxmlformats.org/officeDocument/2006/relationships/image" Target="../media/image37.emf"/><Relationship Id="rId4" Type="http://schemas.openxmlformats.org/officeDocument/2006/relationships/image" Target="../media/image31.emf"/><Relationship Id="rId9" Type="http://schemas.openxmlformats.org/officeDocument/2006/relationships/image" Target="../media/image3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4267200" y="228600"/>
            <a:ext cx="2166619" cy="1260161"/>
            <a:chOff x="852410" y="590019"/>
            <a:chExt cx="2166619" cy="1260161"/>
          </a:xfrm>
        </p:grpSpPr>
        <p:sp>
          <p:nvSpPr>
            <p:cNvPr id="11" name="TextBox 10"/>
            <p:cNvSpPr txBox="1"/>
            <p:nvPr/>
          </p:nvSpPr>
          <p:spPr>
            <a:xfrm>
              <a:off x="1135219" y="590019"/>
              <a:ext cx="181534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itchFamily="34" charset="0"/>
                  <a:cs typeface="Arial" pitchFamily="34" charset="0"/>
                </a:rPr>
                <a:t>HCC1833 + CHX </a:t>
              </a:r>
            </a:p>
          </p:txBody>
        </p:sp>
        <p:grpSp>
          <p:nvGrpSpPr>
            <p:cNvPr id="13" name="Group 12"/>
            <p:cNvGrpSpPr/>
            <p:nvPr/>
          </p:nvGrpSpPr>
          <p:grpSpPr>
            <a:xfrm>
              <a:off x="852410" y="762915"/>
              <a:ext cx="2166619" cy="1087265"/>
              <a:chOff x="745029" y="710820"/>
              <a:chExt cx="4253999" cy="2352980"/>
            </a:xfrm>
          </p:grpSpPr>
          <p:pic>
            <p:nvPicPr>
              <p:cNvPr id="14" name="Picture 2"/>
              <p:cNvPicPr>
                <a:picLocks noChangeAspect="1" noChangeArrowheads="1"/>
              </p:cNvPicPr>
              <p:nvPr/>
            </p:nvPicPr>
            <p:blipFill>
              <a:blip r:embed="rId2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77365" y="2570088"/>
                <a:ext cx="2881684" cy="49371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1558489" y="710820"/>
                <a:ext cx="3440539" cy="4662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   0      0.5    1       3      4     6  </a:t>
                </a:r>
                <a:r>
                  <a:rPr lang="en-US" sz="800" dirty="0" err="1">
                    <a:latin typeface="Arial" pitchFamily="34" charset="0"/>
                    <a:cs typeface="Arial" pitchFamily="34" charset="0"/>
                  </a:rPr>
                  <a:t>hr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745029" y="2590800"/>
                <a:ext cx="1104901" cy="4662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DUSP6</a:t>
                </a: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802638" y="2197262"/>
                <a:ext cx="1066801" cy="4662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ASCL1</a:t>
                </a:r>
              </a:p>
            </p:txBody>
          </p:sp>
          <p:pic>
            <p:nvPicPr>
              <p:cNvPr id="18" name="Picture 2"/>
              <p:cNvPicPr>
                <a:picLocks noChangeAspect="1" noChangeArrowheads="1"/>
              </p:cNvPicPr>
              <p:nvPr/>
            </p:nvPicPr>
            <p:blipFill>
              <a:blip r:embed="rId3">
                <a:grayscl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76400" y="1600200"/>
                <a:ext cx="2881684" cy="96988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848004" y="1633956"/>
                <a:ext cx="942694" cy="4662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 err="1">
                    <a:latin typeface="Arial" pitchFamily="34" charset="0"/>
                    <a:cs typeface="Arial" pitchFamily="34" charset="0"/>
                  </a:rPr>
                  <a:t>pERK</a:t>
                </a:r>
                <a:endParaRPr lang="en-US" sz="800" dirty="0">
                  <a:latin typeface="Arial" pitchFamily="34" charset="0"/>
                  <a:cs typeface="Arial" pitchFamily="34" charset="0"/>
                </a:endParaRPr>
              </a:p>
            </p:txBody>
          </p:sp>
          <p:pic>
            <p:nvPicPr>
              <p:cNvPr id="20" name="Picture 2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77365" y="1060917"/>
                <a:ext cx="2880719" cy="537240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21" name="TextBox 20"/>
              <p:cNvSpPr txBox="1"/>
              <p:nvPr/>
            </p:nvSpPr>
            <p:spPr>
              <a:xfrm>
                <a:off x="952500" y="1143003"/>
                <a:ext cx="838201" cy="46624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ERK</a:t>
                </a:r>
              </a:p>
            </p:txBody>
          </p:sp>
        </p:grpSp>
      </p:grpSp>
      <p:grpSp>
        <p:nvGrpSpPr>
          <p:cNvPr id="26" name="Group 25"/>
          <p:cNvGrpSpPr/>
          <p:nvPr/>
        </p:nvGrpSpPr>
        <p:grpSpPr>
          <a:xfrm>
            <a:off x="4183399" y="2590800"/>
            <a:ext cx="2453751" cy="1292134"/>
            <a:chOff x="850705" y="1754907"/>
            <a:chExt cx="3106883" cy="1503271"/>
          </a:xfrm>
        </p:grpSpPr>
        <p:grpSp>
          <p:nvGrpSpPr>
            <p:cNvPr id="27" name="Group 26"/>
            <p:cNvGrpSpPr/>
            <p:nvPr/>
          </p:nvGrpSpPr>
          <p:grpSpPr>
            <a:xfrm>
              <a:off x="850705" y="1754907"/>
              <a:ext cx="2519192" cy="1503271"/>
              <a:chOff x="268378" y="650478"/>
              <a:chExt cx="4476809" cy="2607701"/>
            </a:xfrm>
          </p:grpSpPr>
          <p:pic>
            <p:nvPicPr>
              <p:cNvPr id="29" name="Picture 3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00084" y="2665748"/>
                <a:ext cx="2785662" cy="592431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0" name="Picture 4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00084" y="1820148"/>
                <a:ext cx="2785661" cy="339715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1" name="Picture 5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00083" y="2192503"/>
                <a:ext cx="2785661" cy="454046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2" name="Picture 7"/>
              <p:cNvPicPr>
                <a:picLocks noChangeAspect="1"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00084" y="1371600"/>
                <a:ext cx="2785661" cy="429452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33" name="TextBox 32"/>
              <p:cNvSpPr txBox="1"/>
              <p:nvPr/>
            </p:nvSpPr>
            <p:spPr>
              <a:xfrm>
                <a:off x="2017495" y="650478"/>
                <a:ext cx="1816051" cy="434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H889 + CHX</a:t>
                </a: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1468581" y="990600"/>
                <a:ext cx="3276606" cy="43479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0     15      45      120  180 </a:t>
                </a:r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268378" y="1291202"/>
                <a:ext cx="1403812" cy="19255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RK</a:t>
                </a:r>
              </a:p>
              <a:p>
                <a:pPr algn="r"/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53</a:t>
                </a:r>
              </a:p>
              <a:p>
                <a:pPr algn="r"/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DUSP6</a:t>
                </a:r>
              </a:p>
              <a:p>
                <a:pPr algn="r"/>
                <a:endParaRPr lang="en-US" sz="8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SCL1</a:t>
                </a:r>
              </a:p>
            </p:txBody>
          </p:sp>
        </p:grpSp>
        <p:sp>
          <p:nvSpPr>
            <p:cNvPr id="28" name="TextBox 27"/>
            <p:cNvSpPr txBox="1"/>
            <p:nvPr/>
          </p:nvSpPr>
          <p:spPr>
            <a:xfrm>
              <a:off x="3167634" y="1964266"/>
              <a:ext cx="789954" cy="25064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in, CHX</a:t>
              </a:r>
            </a:p>
          </p:txBody>
        </p:sp>
      </p:grpSp>
      <p:grpSp>
        <p:nvGrpSpPr>
          <p:cNvPr id="36" name="Group 35"/>
          <p:cNvGrpSpPr/>
          <p:nvPr/>
        </p:nvGrpSpPr>
        <p:grpSpPr>
          <a:xfrm>
            <a:off x="495881" y="744162"/>
            <a:ext cx="3433204" cy="2837238"/>
            <a:chOff x="557771" y="533400"/>
            <a:chExt cx="3433204" cy="2837238"/>
          </a:xfrm>
        </p:grpSpPr>
        <p:sp>
          <p:nvSpPr>
            <p:cNvPr id="37" name="TextBox 36"/>
            <p:cNvSpPr txBox="1"/>
            <p:nvPr/>
          </p:nvSpPr>
          <p:spPr>
            <a:xfrm>
              <a:off x="557771" y="533400"/>
              <a:ext cx="79901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itchFamily="34" charset="0"/>
                  <a:cs typeface="Arial" pitchFamily="34" charset="0"/>
                </a:rPr>
                <a:t>HCC1833</a:t>
              </a:r>
            </a:p>
          </p:txBody>
        </p:sp>
        <p:grpSp>
          <p:nvGrpSpPr>
            <p:cNvPr id="38" name="Group 37"/>
            <p:cNvGrpSpPr/>
            <p:nvPr/>
          </p:nvGrpSpPr>
          <p:grpSpPr>
            <a:xfrm>
              <a:off x="578668" y="716475"/>
              <a:ext cx="3412307" cy="2654163"/>
              <a:chOff x="578668" y="716475"/>
              <a:chExt cx="3412307" cy="2654163"/>
            </a:xfrm>
          </p:grpSpPr>
          <p:grpSp>
            <p:nvGrpSpPr>
              <p:cNvPr id="39" name="Group 38"/>
              <p:cNvGrpSpPr/>
              <p:nvPr/>
            </p:nvGrpSpPr>
            <p:grpSpPr>
              <a:xfrm>
                <a:off x="578668" y="716475"/>
                <a:ext cx="3412307" cy="2654163"/>
                <a:chOff x="288178" y="716475"/>
                <a:chExt cx="3412307" cy="2654163"/>
              </a:xfrm>
            </p:grpSpPr>
            <p:grpSp>
              <p:nvGrpSpPr>
                <p:cNvPr id="52" name="Group 51"/>
                <p:cNvGrpSpPr/>
                <p:nvPr/>
              </p:nvGrpSpPr>
              <p:grpSpPr>
                <a:xfrm>
                  <a:off x="291458" y="1597968"/>
                  <a:ext cx="3342507" cy="816965"/>
                  <a:chOff x="291458" y="837863"/>
                  <a:chExt cx="3342507" cy="816965"/>
                </a:xfrm>
              </p:grpSpPr>
              <p:pic>
                <p:nvPicPr>
                  <p:cNvPr id="67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41785" y="1101353"/>
                    <a:ext cx="2699543" cy="406091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68" name="Picture 6"/>
                  <p:cNvPicPr>
                    <a:picLocks noChangeAspect="1" noChangeArrowheads="1"/>
                  </p:cNvPicPr>
                  <p:nvPr/>
                </p:nvPicPr>
                <p:blipFill>
                  <a:blip r:embed="rId1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41785" y="1507443"/>
                    <a:ext cx="2699543" cy="147385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69" name="TextBox 68"/>
                  <p:cNvSpPr txBox="1"/>
                  <p:nvPr/>
                </p:nvSpPr>
                <p:spPr>
                  <a:xfrm>
                    <a:off x="291458" y="901275"/>
                    <a:ext cx="321374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Arial Narrow" pitchFamily="34" charset="0"/>
                        <a:cs typeface="Arial" pitchFamily="34" charset="0"/>
                      </a:rPr>
                      <a:t>MW  0     PD    15   15     30   30    45    45   60    60   180  180   0   PD</a:t>
                    </a:r>
                  </a:p>
                </p:txBody>
              </p:sp>
              <p:sp>
                <p:nvSpPr>
                  <p:cNvPr id="70" name="TextBox 69"/>
                  <p:cNvSpPr txBox="1"/>
                  <p:nvPr/>
                </p:nvSpPr>
                <p:spPr>
                  <a:xfrm>
                    <a:off x="3093907" y="837863"/>
                    <a:ext cx="540058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rgbClr val="C00000"/>
                        </a:solidFill>
                        <a:latin typeface="Arial Narrow" pitchFamily="34" charset="0"/>
                        <a:cs typeface="Arial" pitchFamily="34" charset="0"/>
                      </a:rPr>
                      <a:t>CHX</a:t>
                    </a:r>
                  </a:p>
                </p:txBody>
              </p:sp>
            </p:grpSp>
            <p:grpSp>
              <p:nvGrpSpPr>
                <p:cNvPr id="53" name="Group 52"/>
                <p:cNvGrpSpPr/>
                <p:nvPr/>
              </p:nvGrpSpPr>
              <p:grpSpPr>
                <a:xfrm>
                  <a:off x="341784" y="716475"/>
                  <a:ext cx="3267752" cy="786742"/>
                  <a:chOff x="341784" y="1707075"/>
                  <a:chExt cx="3267752" cy="786742"/>
                </a:xfrm>
              </p:grpSpPr>
              <p:pic>
                <p:nvPicPr>
                  <p:cNvPr id="63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1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41784" y="1942592"/>
                    <a:ext cx="2699543" cy="406091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64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1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41784" y="2346432"/>
                    <a:ext cx="2699543" cy="147385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65" name="TextBox 64"/>
                  <p:cNvSpPr txBox="1"/>
                  <p:nvPr/>
                </p:nvSpPr>
                <p:spPr>
                  <a:xfrm>
                    <a:off x="3131403" y="1707075"/>
                    <a:ext cx="478133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accent3">
                            <a:lumMod val="75000"/>
                          </a:schemeClr>
                        </a:solidFill>
                        <a:latin typeface="Arial Narrow" pitchFamily="34" charset="0"/>
                        <a:cs typeface="Arial" pitchFamily="34" charset="0"/>
                      </a:rPr>
                      <a:t>PD</a:t>
                    </a:r>
                  </a:p>
                </p:txBody>
              </p:sp>
              <p:sp>
                <p:nvSpPr>
                  <p:cNvPr id="66" name="TextBox 65"/>
                  <p:cNvSpPr txBox="1"/>
                  <p:nvPr/>
                </p:nvSpPr>
                <p:spPr>
                  <a:xfrm>
                    <a:off x="367659" y="1753622"/>
                    <a:ext cx="321374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Arial Narrow" pitchFamily="34" charset="0"/>
                        <a:cs typeface="Arial" pitchFamily="34" charset="0"/>
                      </a:rPr>
                      <a:t>0     PD    15   15   30   30    45   45   60    60   180  180  0    PD   MW</a:t>
                    </a:r>
                  </a:p>
                </p:txBody>
              </p:sp>
            </p:grpSp>
            <p:grpSp>
              <p:nvGrpSpPr>
                <p:cNvPr id="54" name="Group 53"/>
                <p:cNvGrpSpPr/>
                <p:nvPr/>
              </p:nvGrpSpPr>
              <p:grpSpPr>
                <a:xfrm>
                  <a:off x="288178" y="2545351"/>
                  <a:ext cx="3412307" cy="825287"/>
                  <a:chOff x="288178" y="2516776"/>
                  <a:chExt cx="3412307" cy="825287"/>
                </a:xfrm>
              </p:grpSpPr>
              <p:pic>
                <p:nvPicPr>
                  <p:cNvPr id="55" name="Picture 5"/>
                  <p:cNvPicPr>
                    <a:picLocks noChangeAspect="1" noChangeArrowheads="1"/>
                  </p:cNvPicPr>
                  <p:nvPr/>
                </p:nvPicPr>
                <p:blipFill>
                  <a:blip r:embed="rId1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20334" y="2731016"/>
                    <a:ext cx="2699543" cy="407280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60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14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319688" y="3138296"/>
                    <a:ext cx="2700188" cy="203767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sp>
                <p:nvSpPr>
                  <p:cNvPr id="61" name="TextBox 60"/>
                  <p:cNvSpPr txBox="1"/>
                  <p:nvPr/>
                </p:nvSpPr>
                <p:spPr>
                  <a:xfrm>
                    <a:off x="3016055" y="2516776"/>
                    <a:ext cx="684430" cy="230832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b="1" dirty="0">
                        <a:solidFill>
                          <a:schemeClr val="accent1"/>
                        </a:solidFill>
                        <a:latin typeface="Arial Narrow" pitchFamily="34" charset="0"/>
                        <a:cs typeface="Arial" pitchFamily="34" charset="0"/>
                      </a:rPr>
                      <a:t>CHX+PD</a:t>
                    </a:r>
                  </a:p>
                </p:txBody>
              </p:sp>
              <p:sp>
                <p:nvSpPr>
                  <p:cNvPr id="62" name="TextBox 61"/>
                  <p:cNvSpPr txBox="1"/>
                  <p:nvPr/>
                </p:nvSpPr>
                <p:spPr>
                  <a:xfrm>
                    <a:off x="288178" y="2536983"/>
                    <a:ext cx="321374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dirty="0">
                        <a:latin typeface="Arial Narrow" pitchFamily="34" charset="0"/>
                        <a:cs typeface="Arial" pitchFamily="34" charset="0"/>
                      </a:rPr>
                      <a:t> 0     PD   15   15    30   30    45           60    60   180  180   0   MW PD</a:t>
                    </a:r>
                  </a:p>
                </p:txBody>
              </p:sp>
            </p:grpSp>
          </p:grpSp>
          <p:grpSp>
            <p:nvGrpSpPr>
              <p:cNvPr id="40" name="Group 39"/>
              <p:cNvGrpSpPr/>
              <p:nvPr/>
            </p:nvGrpSpPr>
            <p:grpSpPr>
              <a:xfrm>
                <a:off x="3320996" y="941042"/>
                <a:ext cx="484428" cy="616093"/>
                <a:chOff x="3352800" y="941042"/>
                <a:chExt cx="484428" cy="616093"/>
              </a:xfrm>
            </p:grpSpPr>
            <p:sp>
              <p:nvSpPr>
                <p:cNvPr id="49" name="TextBox 48"/>
                <p:cNvSpPr txBox="1"/>
                <p:nvPr/>
              </p:nvSpPr>
              <p:spPr>
                <a:xfrm>
                  <a:off x="3352800" y="941042"/>
                  <a:ext cx="4315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err="1">
                      <a:latin typeface="Arial Narrow" pitchFamily="34" charset="0"/>
                    </a:rPr>
                    <a:t>pERK</a:t>
                  </a:r>
                  <a:endParaRPr lang="en-US" sz="900" dirty="0">
                    <a:latin typeface="Arial Narrow" pitchFamily="34" charset="0"/>
                  </a:endParaRPr>
                </a:p>
              </p:txBody>
            </p:sp>
            <p:sp>
              <p:nvSpPr>
                <p:cNvPr id="50" name="TextBox 49"/>
                <p:cNvSpPr txBox="1"/>
                <p:nvPr/>
              </p:nvSpPr>
              <p:spPr>
                <a:xfrm>
                  <a:off x="3352800" y="1129697"/>
                  <a:ext cx="4844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Arial Narrow" pitchFamily="34" charset="0"/>
                    </a:rPr>
                    <a:t>ASCL1</a:t>
                  </a:r>
                </a:p>
              </p:txBody>
            </p:sp>
            <p:sp>
              <p:nvSpPr>
                <p:cNvPr id="51" name="TextBox 50"/>
                <p:cNvSpPr txBox="1"/>
                <p:nvPr/>
              </p:nvSpPr>
              <p:spPr>
                <a:xfrm>
                  <a:off x="3352800" y="1326303"/>
                  <a:ext cx="37863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Arial Narrow" pitchFamily="34" charset="0"/>
                    </a:rPr>
                    <a:t>ERK</a:t>
                  </a:r>
                </a:p>
              </p:txBody>
            </p:sp>
          </p:grpSp>
          <p:grpSp>
            <p:nvGrpSpPr>
              <p:cNvPr id="41" name="Group 40"/>
              <p:cNvGrpSpPr/>
              <p:nvPr/>
            </p:nvGrpSpPr>
            <p:grpSpPr>
              <a:xfrm>
                <a:off x="3292502" y="2743200"/>
                <a:ext cx="484428" cy="616093"/>
                <a:chOff x="3352800" y="941042"/>
                <a:chExt cx="484428" cy="616093"/>
              </a:xfrm>
            </p:grpSpPr>
            <p:sp>
              <p:nvSpPr>
                <p:cNvPr id="46" name="TextBox 45"/>
                <p:cNvSpPr txBox="1"/>
                <p:nvPr/>
              </p:nvSpPr>
              <p:spPr>
                <a:xfrm>
                  <a:off x="3352800" y="941042"/>
                  <a:ext cx="4315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err="1">
                      <a:latin typeface="Arial Narrow" pitchFamily="34" charset="0"/>
                    </a:rPr>
                    <a:t>pERK</a:t>
                  </a:r>
                  <a:endParaRPr lang="en-US" sz="900" dirty="0">
                    <a:latin typeface="Arial Narrow" pitchFamily="34" charset="0"/>
                  </a:endParaRPr>
                </a:p>
              </p:txBody>
            </p:sp>
            <p:sp>
              <p:nvSpPr>
                <p:cNvPr id="47" name="TextBox 46"/>
                <p:cNvSpPr txBox="1"/>
                <p:nvPr/>
              </p:nvSpPr>
              <p:spPr>
                <a:xfrm>
                  <a:off x="3352800" y="1129697"/>
                  <a:ext cx="4844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Arial Narrow" pitchFamily="34" charset="0"/>
                    </a:rPr>
                    <a:t>ASCL1</a:t>
                  </a:r>
                </a:p>
              </p:txBody>
            </p:sp>
            <p:sp>
              <p:nvSpPr>
                <p:cNvPr id="48" name="TextBox 47"/>
                <p:cNvSpPr txBox="1"/>
                <p:nvPr/>
              </p:nvSpPr>
              <p:spPr>
                <a:xfrm>
                  <a:off x="3352800" y="1326303"/>
                  <a:ext cx="37863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Arial Narrow" pitchFamily="34" charset="0"/>
                    </a:rPr>
                    <a:t>ERK</a:t>
                  </a:r>
                </a:p>
              </p:txBody>
            </p:sp>
          </p:grpSp>
          <p:grpSp>
            <p:nvGrpSpPr>
              <p:cNvPr id="42" name="Group 41"/>
              <p:cNvGrpSpPr/>
              <p:nvPr/>
            </p:nvGrpSpPr>
            <p:grpSpPr>
              <a:xfrm>
                <a:off x="3317621" y="1822307"/>
                <a:ext cx="484428" cy="616093"/>
                <a:chOff x="3352800" y="941042"/>
                <a:chExt cx="484428" cy="616093"/>
              </a:xfrm>
            </p:grpSpPr>
            <p:sp>
              <p:nvSpPr>
                <p:cNvPr id="43" name="TextBox 42"/>
                <p:cNvSpPr txBox="1"/>
                <p:nvPr/>
              </p:nvSpPr>
              <p:spPr>
                <a:xfrm>
                  <a:off x="3352800" y="941042"/>
                  <a:ext cx="4315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 err="1">
                      <a:latin typeface="Arial Narrow" pitchFamily="34" charset="0"/>
                    </a:rPr>
                    <a:t>pERK</a:t>
                  </a:r>
                  <a:endParaRPr lang="en-US" sz="900" dirty="0">
                    <a:latin typeface="Arial Narrow" pitchFamily="34" charset="0"/>
                  </a:endParaRPr>
                </a:p>
              </p:txBody>
            </p:sp>
            <p:sp>
              <p:nvSpPr>
                <p:cNvPr id="44" name="TextBox 43"/>
                <p:cNvSpPr txBox="1"/>
                <p:nvPr/>
              </p:nvSpPr>
              <p:spPr>
                <a:xfrm>
                  <a:off x="3352800" y="1129697"/>
                  <a:ext cx="484428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Arial Narrow" pitchFamily="34" charset="0"/>
                    </a:rPr>
                    <a:t>ASCL1</a:t>
                  </a:r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>
                <a:xfrm>
                  <a:off x="3352800" y="1326303"/>
                  <a:ext cx="378630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Arial Narrow" pitchFamily="34" charset="0"/>
                    </a:rPr>
                    <a:t>ERK</a:t>
                  </a:r>
                </a:p>
              </p:txBody>
            </p:sp>
          </p:grpSp>
        </p:grpSp>
      </p:grpSp>
      <p:sp>
        <p:nvSpPr>
          <p:cNvPr id="71" name="TextBox 70"/>
          <p:cNvSpPr txBox="1"/>
          <p:nvPr/>
        </p:nvSpPr>
        <p:spPr>
          <a:xfrm>
            <a:off x="152400" y="3048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3742851" y="4150320"/>
            <a:ext cx="2429349" cy="1717080"/>
            <a:chOff x="3576211" y="732994"/>
            <a:chExt cx="2463824" cy="1705412"/>
          </a:xfrm>
        </p:grpSpPr>
        <p:grpSp>
          <p:nvGrpSpPr>
            <p:cNvPr id="82" name="Group 81"/>
            <p:cNvGrpSpPr/>
            <p:nvPr/>
          </p:nvGrpSpPr>
          <p:grpSpPr>
            <a:xfrm>
              <a:off x="3576211" y="732994"/>
              <a:ext cx="2463824" cy="1705412"/>
              <a:chOff x="757742" y="2430416"/>
              <a:chExt cx="2463824" cy="1705412"/>
            </a:xfrm>
          </p:grpSpPr>
          <p:sp>
            <p:nvSpPr>
              <p:cNvPr id="84" name="TextBox 83"/>
              <p:cNvSpPr txBox="1"/>
              <p:nvPr/>
            </p:nvSpPr>
            <p:spPr>
              <a:xfrm>
                <a:off x="1656177" y="3920384"/>
                <a:ext cx="90922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Log [AZD6244]</a:t>
                </a: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 rot="16200000">
                <a:off x="321885" y="3048893"/>
                <a:ext cx="108715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Viability (% Control)</a:t>
                </a: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1064126" y="3754822"/>
                <a:ext cx="215744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-9       -8        -7        -6       -5       -4        -3   </a:t>
                </a:r>
              </a:p>
            </p:txBody>
          </p:sp>
          <p:sp>
            <p:nvSpPr>
              <p:cNvPr id="87" name="TextBox 86"/>
              <p:cNvSpPr txBox="1"/>
              <p:nvPr/>
            </p:nvSpPr>
            <p:spPr>
              <a:xfrm>
                <a:off x="931533" y="3273696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40</a:t>
                </a:r>
              </a:p>
            </p:txBody>
          </p:sp>
          <p:sp>
            <p:nvSpPr>
              <p:cNvPr id="88" name="TextBox 87"/>
              <p:cNvSpPr txBox="1"/>
              <p:nvPr/>
            </p:nvSpPr>
            <p:spPr>
              <a:xfrm>
                <a:off x="873760" y="2430416"/>
                <a:ext cx="357855" cy="144655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100</a:t>
                </a: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0</a:t>
                </a: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931533" y="3068988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60</a:t>
                </a: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873760" y="2482643"/>
                <a:ext cx="357855" cy="120032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120</a:t>
                </a: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endParaRPr lang="en-US" sz="800" dirty="0">
                  <a:latin typeface="Arial" pitchFamily="34" charset="0"/>
                  <a:cs typeface="Arial" pitchFamily="34" charset="0"/>
                </a:endParaRPr>
              </a:p>
              <a:p>
                <a:pPr algn="r"/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20</a:t>
                </a: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931533" y="2879607"/>
                <a:ext cx="30008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sz="800" dirty="0">
                    <a:latin typeface="Arial" pitchFamily="34" charset="0"/>
                    <a:cs typeface="Arial" pitchFamily="34" charset="0"/>
                  </a:rPr>
                  <a:t>80</a:t>
                </a:r>
              </a:p>
            </p:txBody>
          </p:sp>
        </p:grpSp>
        <p:pic>
          <p:nvPicPr>
            <p:cNvPr id="2050" name="Picture 2" descr="E:\HCC1833 AZD6244 black.tif"/>
            <p:cNvPicPr>
              <a:picLocks noChangeAspect="1" noChangeArrowheads="1"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413" t="15937" r="3015" b="18380"/>
            <a:stretch/>
          </p:blipFill>
          <p:spPr bwMode="auto">
            <a:xfrm>
              <a:off x="3988073" y="846666"/>
              <a:ext cx="1955527" cy="1258933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1" name="TextBox 80"/>
            <p:cNvSpPr txBox="1"/>
            <p:nvPr/>
          </p:nvSpPr>
          <p:spPr>
            <a:xfrm>
              <a:off x="5271717" y="902014"/>
              <a:ext cx="63671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HCC1833</a:t>
              </a:r>
            </a:p>
          </p:txBody>
        </p:sp>
      </p:grpSp>
      <p:sp>
        <p:nvSpPr>
          <p:cNvPr id="75" name="TextBox 74"/>
          <p:cNvSpPr txBox="1"/>
          <p:nvPr/>
        </p:nvSpPr>
        <p:spPr>
          <a:xfrm>
            <a:off x="3921995" y="2476718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3937924" y="306393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3405147" y="384270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E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152400" y="384270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4572000" y="1447800"/>
            <a:ext cx="1539423" cy="1104327"/>
            <a:chOff x="2422977" y="3987917"/>
            <a:chExt cx="1539423" cy="1104327"/>
          </a:xfrm>
        </p:grpSpPr>
        <p:sp>
          <p:nvSpPr>
            <p:cNvPr id="4" name="TextBox 3"/>
            <p:cNvSpPr txBox="1"/>
            <p:nvPr/>
          </p:nvSpPr>
          <p:spPr>
            <a:xfrm rot="16200000">
              <a:off x="2068029" y="4342865"/>
              <a:ext cx="92533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elative DUSP6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933704" y="4876800"/>
              <a:ext cx="85311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ime (hours)   </a:t>
              </a:r>
            </a:p>
          </p:txBody>
        </p:sp>
        <p:pic>
          <p:nvPicPr>
            <p:cNvPr id="78" name="Picture 3" descr="C:\Users\Cobb\Desktop\ASCL-SMASH\CHX-HCC1833-H889\sveta degradation data.tif"/>
            <p:cNvPicPr>
              <a:picLocks noChangeAspect="1"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39" t="27483" r="26892" b="18742"/>
            <a:stretch/>
          </p:blipFill>
          <p:spPr bwMode="auto">
            <a:xfrm>
              <a:off x="2782873" y="4110039"/>
              <a:ext cx="1103328" cy="67915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TextBox 6"/>
            <p:cNvSpPr txBox="1"/>
            <p:nvPr/>
          </p:nvSpPr>
          <p:spPr>
            <a:xfrm>
              <a:off x="2524954" y="4054063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2524954" y="4341769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611516" y="463216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3027981" y="473755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3361678" y="473755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3720026" y="473755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2687395" y="4737556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DA2490B6-F1F3-15E6-5E0C-490F81672DD4}"/>
              </a:ext>
            </a:extLst>
          </p:cNvPr>
          <p:cNvSpPr txBox="1"/>
          <p:nvPr/>
        </p:nvSpPr>
        <p:spPr>
          <a:xfrm>
            <a:off x="503778" y="6489736"/>
            <a:ext cx="6029186" cy="17851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1.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 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K inhibition increases ASCL1 protein expression but does not affect protein stability or cell viability. Related to Figure 1.</a:t>
            </a:r>
            <a:endParaRPr lang="en-US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 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B.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CC1833 cells were treated with 1 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μM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D0325901 or DMSO control prior to the addition of 128 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μM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ycloheximide (CHX) or diluent. 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. 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me courses of ASCL1 protein measured by immunoblotting with guinea pig antibody under all three conditions are shown. Quantitation is in Figure 1B. ERK and 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ERK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blots are also shown. N=2 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.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ells were exposed to cycloheximide over 6 hours. ASCL1, ERK, 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ERK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DUSP6 were immunoblotted over the time course and the quantitation of DUSP6 from one of two experiments is shown on the right. 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.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889 cells were treated with 128 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μM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cycloheximide over 3 hours.  ASCL1 and DUSP6 were immunoblotted, along with ERK and p53 as controls. N=2 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.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The sensitivity of H889 cells to the clinically used MEK inhibitor AZD6244, which has a reported IC</a:t>
            </a:r>
            <a:r>
              <a:rPr lang="en-US" sz="1000" baseline="-25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50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~10 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M.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8 technical replicates, N=2. 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. 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ZD6244 concentration dependence of HCC1833 cell viability. </a:t>
            </a: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A3B4F335-7EE6-AB0E-AEA7-069CF74C517E}"/>
              </a:ext>
            </a:extLst>
          </p:cNvPr>
          <p:cNvGrpSpPr/>
          <p:nvPr/>
        </p:nvGrpSpPr>
        <p:grpSpPr>
          <a:xfrm>
            <a:off x="480919" y="4205960"/>
            <a:ext cx="2395840" cy="1653135"/>
            <a:chOff x="4234165" y="2359789"/>
            <a:chExt cx="2395840" cy="1653135"/>
          </a:xfrm>
        </p:grpSpPr>
        <p:pic>
          <p:nvPicPr>
            <p:cNvPr id="12" name="Picture 2" descr="C:\Users\Swan\Documents\My Files Integrated\Manuscripts\Svetlana\Ascl1 dusp6 7 16\Ascl1 Dusp6 Fig 6 16 20.tif">
              <a:extLst>
                <a:ext uri="{FF2B5EF4-FFF2-40B4-BE49-F238E27FC236}">
                  <a16:creationId xmlns:a16="http://schemas.microsoft.com/office/drawing/2014/main" id="{001097A9-31DB-02CF-A028-EFB1D2F45F5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833" t="81207"/>
            <a:stretch/>
          </p:blipFill>
          <p:spPr bwMode="auto">
            <a:xfrm>
              <a:off x="4234165" y="2359789"/>
              <a:ext cx="2395840" cy="165313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3C0D0F33-B6DC-3D32-48F4-CB344E41639E}"/>
                </a:ext>
              </a:extLst>
            </p:cNvPr>
            <p:cNvSpPr txBox="1"/>
            <p:nvPr/>
          </p:nvSpPr>
          <p:spPr>
            <a:xfrm>
              <a:off x="6121672" y="2438400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H889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597616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3429000" y="609600"/>
            <a:ext cx="2065200" cy="2150100"/>
            <a:chOff x="4308273" y="1399401"/>
            <a:chExt cx="2065200" cy="2150100"/>
          </a:xfrm>
        </p:grpSpPr>
        <p:grpSp>
          <p:nvGrpSpPr>
            <p:cNvPr id="4" name="Group 3"/>
            <p:cNvGrpSpPr/>
            <p:nvPr/>
          </p:nvGrpSpPr>
          <p:grpSpPr>
            <a:xfrm>
              <a:off x="4308273" y="1447800"/>
              <a:ext cx="2065200" cy="2101701"/>
              <a:chOff x="4050911" y="1554155"/>
              <a:chExt cx="2065200" cy="2101699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4050911" y="1554155"/>
                <a:ext cx="2065200" cy="2101699"/>
                <a:chOff x="486628" y="-455235"/>
                <a:chExt cx="4161059" cy="4233711"/>
              </a:xfrm>
            </p:grpSpPr>
            <p:sp>
              <p:nvSpPr>
                <p:cNvPr id="19" name="TextBox 18"/>
                <p:cNvSpPr txBox="1"/>
                <p:nvPr/>
              </p:nvSpPr>
              <p:spPr>
                <a:xfrm>
                  <a:off x="518587" y="-455235"/>
                  <a:ext cx="1108469" cy="5579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itchFamily="34" charset="0"/>
                      <a:cs typeface="Arial" pitchFamily="34" charset="0"/>
                    </a:rPr>
                    <a:t>H889</a:t>
                  </a:r>
                </a:p>
              </p:txBody>
            </p:sp>
            <p:pic>
              <p:nvPicPr>
                <p:cNvPr id="20" name="Picture 6"/>
                <p:cNvPicPr>
                  <a:picLocks noChangeAspect="1" noChangeArrowheads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911" t="29911" r="29910" b="29910"/>
                <a:stretch/>
              </p:blipFill>
              <p:spPr bwMode="auto">
                <a:xfrm>
                  <a:off x="1750043" y="873333"/>
                  <a:ext cx="1371599" cy="1371600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21" name="Picture 7"/>
                <p:cNvPicPr>
                  <a:picLocks noChangeAspect="1" noChangeArrowheads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1599" r="38223" b="59671"/>
                <a:stretch/>
              </p:blipFill>
              <p:spPr bwMode="auto">
                <a:xfrm>
                  <a:off x="3271934" y="873333"/>
                  <a:ext cx="1371600" cy="137673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24" name="TextBox 23"/>
                <p:cNvSpPr txBox="1"/>
                <p:nvPr/>
              </p:nvSpPr>
              <p:spPr>
                <a:xfrm>
                  <a:off x="486628" y="1180328"/>
                  <a:ext cx="1299025" cy="55799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>
                      <a:latin typeface="Arial" pitchFamily="34" charset="0"/>
                      <a:cs typeface="Arial" pitchFamily="34" charset="0"/>
                    </a:rPr>
                    <a:t>10 min</a:t>
                  </a: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3335657" y="321861"/>
                  <a:ext cx="1108467" cy="55799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1200" dirty="0">
                      <a:latin typeface="Arial" pitchFamily="34" charset="0"/>
                      <a:cs typeface="Arial" pitchFamily="34" charset="0"/>
                    </a:rPr>
                    <a:t>BCI</a:t>
                  </a:r>
                </a:p>
              </p:txBody>
            </p:sp>
            <p:pic>
              <p:nvPicPr>
                <p:cNvPr id="30" name="Picture 4"/>
                <p:cNvPicPr>
                  <a:picLocks noChangeAspect="1" noChangeArrowheads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4464" t="19882" r="5357" b="39939"/>
                <a:stretch/>
              </p:blipFill>
              <p:spPr bwMode="auto">
                <a:xfrm>
                  <a:off x="1737749" y="2406877"/>
                  <a:ext cx="1371600" cy="13715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43" name="Picture 6"/>
                <p:cNvPicPr>
                  <a:picLocks noChangeAspect="1" noChangeArrowheads="1"/>
                </p:cNvPicPr>
                <p:nvPr/>
              </p:nvPicPr>
              <p:blipFill rotWithShape="1">
                <a:blip r:embed="rId5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0091" t="21052" r="39731" b="38769"/>
                <a:stretch/>
              </p:blipFill>
              <p:spPr bwMode="auto">
                <a:xfrm>
                  <a:off x="3276087" y="2375567"/>
                  <a:ext cx="1371600" cy="1371597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sp>
            <p:nvSpPr>
              <p:cNvPr id="31" name="TextBox 30"/>
              <p:cNvSpPr txBox="1"/>
              <p:nvPr/>
            </p:nvSpPr>
            <p:spPr>
              <a:xfrm>
                <a:off x="4072176" y="3155882"/>
                <a:ext cx="64472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Arial" pitchFamily="34" charset="0"/>
                    <a:cs typeface="Arial" pitchFamily="34" charset="0"/>
                  </a:rPr>
                  <a:t>30 min</a:t>
                </a:r>
              </a:p>
            </p:txBody>
          </p:sp>
        </p:grpSp>
        <p:sp>
          <p:nvSpPr>
            <p:cNvPr id="34" name="TextBox 33"/>
            <p:cNvSpPr txBox="1"/>
            <p:nvPr/>
          </p:nvSpPr>
          <p:spPr>
            <a:xfrm>
              <a:off x="5264488" y="1399401"/>
              <a:ext cx="6029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err="1">
                  <a:latin typeface="Arial" pitchFamily="34" charset="0"/>
                  <a:cs typeface="Arial" pitchFamily="34" charset="0"/>
                </a:rPr>
                <a:t>pERK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4867532" y="1822933"/>
              <a:ext cx="8031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 pitchFamily="34" charset="0"/>
                  <a:cs typeface="Arial" pitchFamily="34" charset="0"/>
                </a:rPr>
                <a:t>DMSO</a:t>
              </a:r>
            </a:p>
          </p:txBody>
        </p:sp>
      </p:grpSp>
      <p:sp>
        <p:nvSpPr>
          <p:cNvPr id="38" name="TextBox 37"/>
          <p:cNvSpPr txBox="1"/>
          <p:nvPr/>
        </p:nvSpPr>
        <p:spPr>
          <a:xfrm>
            <a:off x="297694" y="3048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3166646" y="3048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grpSp>
        <p:nvGrpSpPr>
          <p:cNvPr id="40" name="Group 39"/>
          <p:cNvGrpSpPr/>
          <p:nvPr/>
        </p:nvGrpSpPr>
        <p:grpSpPr>
          <a:xfrm>
            <a:off x="685800" y="4648200"/>
            <a:ext cx="4419600" cy="2569385"/>
            <a:chOff x="2352820" y="99626"/>
            <a:chExt cx="6624556" cy="4518512"/>
          </a:xfrm>
        </p:grpSpPr>
        <p:pic>
          <p:nvPicPr>
            <p:cNvPr id="41" name="Picture 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62200" y="968584"/>
              <a:ext cx="4747442" cy="43010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6" name="Picture 3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62200" y="1418561"/>
              <a:ext cx="4747443" cy="42710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7" name="Picture 7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61352" y="3467624"/>
              <a:ext cx="4747443" cy="45837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8" name="Picture 8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52820" y="3945863"/>
              <a:ext cx="4747443" cy="67227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9" name="TextBox 48"/>
            <p:cNvSpPr txBox="1"/>
            <p:nvPr/>
          </p:nvSpPr>
          <p:spPr>
            <a:xfrm>
              <a:off x="7108796" y="933436"/>
              <a:ext cx="914400" cy="378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ERK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7120529" y="1473746"/>
              <a:ext cx="1066800" cy="378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itchFamily="34" charset="0"/>
                  <a:cs typeface="Arial" pitchFamily="34" charset="0"/>
                </a:rPr>
                <a:t>pERK</a:t>
              </a:r>
              <a:endParaRPr 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7120529" y="1905000"/>
              <a:ext cx="1856847" cy="378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pMEK1 Ser217/221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7110489" y="3578174"/>
              <a:ext cx="1203959" cy="378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itchFamily="34" charset="0"/>
                  <a:cs typeface="Arial" pitchFamily="34" charset="0"/>
                </a:rPr>
                <a:t>pAKT</a:t>
              </a:r>
              <a:r>
                <a:rPr lang="en-US" sz="800" dirty="0">
                  <a:latin typeface="Arial" pitchFamily="34" charset="0"/>
                  <a:cs typeface="Arial" pitchFamily="34" charset="0"/>
                </a:rPr>
                <a:t> Ser473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7131416" y="4142557"/>
              <a:ext cx="1447800" cy="378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itchFamily="34" charset="0"/>
                  <a:cs typeface="Arial" pitchFamily="34" charset="0"/>
                </a:rPr>
                <a:t>pJNK</a:t>
              </a:r>
              <a:r>
                <a:rPr lang="en-US" sz="800" dirty="0">
                  <a:latin typeface="Arial" pitchFamily="34" charset="0"/>
                  <a:cs typeface="Arial" pitchFamily="34" charset="0"/>
                </a:rPr>
                <a:t> T183/Y185</a:t>
              </a:r>
            </a:p>
          </p:txBody>
        </p:sp>
        <p:cxnSp>
          <p:nvCxnSpPr>
            <p:cNvPr id="54" name="Straight Connector 53"/>
            <p:cNvCxnSpPr/>
            <p:nvPr/>
          </p:nvCxnSpPr>
          <p:spPr>
            <a:xfrm>
              <a:off x="2506978" y="762000"/>
              <a:ext cx="130302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>
              <a:off x="3962400" y="762000"/>
              <a:ext cx="1295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>
              <a:off x="5334000" y="762000"/>
              <a:ext cx="16764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2352820" y="414214"/>
              <a:ext cx="4975952" cy="378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C    PD    BCI   SCH    C    PD   BCI  SCH    C      PD     BCI    SCH</a:t>
              </a:r>
            </a:p>
          </p:txBody>
        </p:sp>
        <p:pic>
          <p:nvPicPr>
            <p:cNvPr id="59" name="Picture 2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62199" y="2424702"/>
              <a:ext cx="4747443" cy="46828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0" name="Picture 3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61352" y="2912855"/>
              <a:ext cx="4748289" cy="5349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1" name="Picture 4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63046" y="1865537"/>
              <a:ext cx="4747443" cy="53929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2" name="TextBox 61"/>
            <p:cNvSpPr txBox="1"/>
            <p:nvPr/>
          </p:nvSpPr>
          <p:spPr>
            <a:xfrm>
              <a:off x="7108794" y="3071535"/>
              <a:ext cx="849934" cy="378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DUSP6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7108796" y="2547288"/>
              <a:ext cx="1066798" cy="378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ASCL1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819401" y="99626"/>
              <a:ext cx="3962400" cy="3788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itchFamily="34" charset="0"/>
                  <a:cs typeface="Arial" pitchFamily="34" charset="0"/>
                </a:rPr>
                <a:t>H889                         H82                       HCC1833</a:t>
              </a:r>
            </a:p>
          </p:txBody>
        </p:sp>
      </p:grpSp>
      <p:sp>
        <p:nvSpPr>
          <p:cNvPr id="65" name="TextBox 64"/>
          <p:cNvSpPr txBox="1"/>
          <p:nvPr/>
        </p:nvSpPr>
        <p:spPr>
          <a:xfrm>
            <a:off x="258222" y="45720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571083" y="418066"/>
            <a:ext cx="2324517" cy="3925334"/>
            <a:chOff x="685800" y="1186190"/>
            <a:chExt cx="2324517" cy="3925334"/>
          </a:xfrm>
        </p:grpSpPr>
        <p:sp>
          <p:nvSpPr>
            <p:cNvPr id="35" name="TextBox 34"/>
            <p:cNvSpPr txBox="1"/>
            <p:nvPr/>
          </p:nvSpPr>
          <p:spPr>
            <a:xfrm>
              <a:off x="1906481" y="1186190"/>
              <a:ext cx="60291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err="1">
                  <a:latin typeface="Arial" pitchFamily="34" charset="0"/>
                  <a:cs typeface="Arial" pitchFamily="34" charset="0"/>
                </a:rPr>
                <a:t>pERK</a:t>
              </a:r>
              <a:endParaRPr lang="en-US" sz="11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67" name="Picture 2" descr="C:\Users\TUO\Documents\My Files 11 13\Manuscripts\Svetlana\Ascl1 relevant 12 15\SE dusp select\Publication ASCL1-DUSP6\Sveta HCC1833_small.tif"/>
            <p:cNvPicPr>
              <a:picLocks noChangeAspect="1"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15" t="28750" r="2592" b="50982"/>
            <a:stretch/>
          </p:blipFill>
          <p:spPr bwMode="auto">
            <a:xfrm rot="5400000">
              <a:off x="25835" y="2974077"/>
              <a:ext cx="3343513" cy="93138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68" name="Picture 2" descr="C:\Users\TUO\Documents\My Files 11 13\Manuscripts\Svetlana\Ascl1 relevant 12 15\SE dusp select\Publication ASCL1-DUSP6\Sveta HCC1833_small.tif"/>
            <p:cNvPicPr>
              <a:picLocks noChangeAspect="1"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15" t="69290" r="3720" b="11632"/>
            <a:stretch/>
          </p:blipFill>
          <p:spPr bwMode="auto">
            <a:xfrm rot="5400000">
              <a:off x="924003" y="2977609"/>
              <a:ext cx="3295912" cy="87671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0" name="TextBox 69"/>
            <p:cNvSpPr txBox="1"/>
            <p:nvPr/>
          </p:nvSpPr>
          <p:spPr>
            <a:xfrm>
              <a:off x="753135" y="1219200"/>
              <a:ext cx="8563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itchFamily="34" charset="0"/>
                  <a:cs typeface="Arial" pitchFamily="34" charset="0"/>
                </a:rPr>
                <a:t>HCC1833</a:t>
              </a: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1433754" y="1525808"/>
              <a:ext cx="620991" cy="2651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itchFamily="34" charset="0"/>
                  <a:cs typeface="Arial" pitchFamily="34" charset="0"/>
                </a:rPr>
                <a:t>DMSO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732428" y="1992615"/>
              <a:ext cx="542318" cy="2651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0 min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698791" y="4535458"/>
              <a:ext cx="619243" cy="2651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30 min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2317930" y="1514358"/>
              <a:ext cx="433925" cy="2651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000" dirty="0">
                  <a:latin typeface="Arial" pitchFamily="34" charset="0"/>
                  <a:cs typeface="Arial" pitchFamily="34" charset="0"/>
                </a:rPr>
                <a:t>BCI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685800" y="3770096"/>
              <a:ext cx="619243" cy="26514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10 min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721948" y="2895600"/>
              <a:ext cx="49725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5 min</a:t>
              </a:r>
            </a:p>
          </p:txBody>
        </p:sp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5776D6E0-B5FD-7D70-9F57-AB20716C75F2}"/>
              </a:ext>
            </a:extLst>
          </p:cNvPr>
          <p:cNvSpPr txBox="1"/>
          <p:nvPr/>
        </p:nvSpPr>
        <p:spPr>
          <a:xfrm>
            <a:off x="466971" y="7592708"/>
            <a:ext cx="6104915" cy="116955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2.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nhibition of DUSP6 increases ERK activity and nuclear localization. Related to Figure 5</a:t>
            </a:r>
            <a:endParaRPr lang="en-US" sz="1000" dirty="0"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.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CC1833 cells were pretreated with 2.5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μM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BCI for 10 and 30 min. The localization of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ERK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was assessed by immunofluorescence as in Figure 5C. Larger fields are shown here. N=2. </a:t>
            </a: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.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889 cells were treated with 2.5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μM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BCI for 10 and 30 min.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ERK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localization was detected by immunofluorescence. N=2. </a:t>
            </a:r>
            <a:r>
              <a:rPr lang="en-US" sz="10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.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889, H82 (ASCL1 low), and HCC1833 cells were pretreated with DMSO control, 1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μM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D0325901 for 2 hours, 25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μM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BCI for 3 hours, or 100 </a:t>
            </a:r>
            <a:r>
              <a:rPr lang="en-US" sz="10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nM</a:t>
            </a:r>
            <a:r>
              <a:rPr lang="en-US" sz="1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CH772984 for 1 hour. The indicated proteins were immunoblotted. One of five similar experiments.</a:t>
            </a:r>
            <a:endParaRPr lang="en-US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06962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56688" y="990600"/>
            <a:ext cx="2748512" cy="1499084"/>
            <a:chOff x="533400" y="1655341"/>
            <a:chExt cx="2748512" cy="1499084"/>
          </a:xfrm>
        </p:grpSpPr>
        <p:pic>
          <p:nvPicPr>
            <p:cNvPr id="32" name="Picture 7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1233855" y="2283774"/>
              <a:ext cx="689980" cy="62443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3" name="Picture 8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533400" y="2283774"/>
              <a:ext cx="689980" cy="62443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4" name="Picture 9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1931699" y="2283774"/>
              <a:ext cx="696884" cy="630678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5" name="Picture 13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537378" y="1655341"/>
              <a:ext cx="696884" cy="62196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6" name="Picture 14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1234263" y="1655341"/>
              <a:ext cx="696884" cy="62196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7" name="Picture 15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1931699" y="1655341"/>
              <a:ext cx="696884" cy="62196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8" name="TextBox 37"/>
            <p:cNvSpPr txBox="1"/>
            <p:nvPr/>
          </p:nvSpPr>
          <p:spPr>
            <a:xfrm>
              <a:off x="2628583" y="1865056"/>
              <a:ext cx="56844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H889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628583" y="2494721"/>
              <a:ext cx="65332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H82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598239" y="2908204"/>
              <a:ext cx="22545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itchFamily="34" charset="0"/>
                  <a:cs typeface="Arial" pitchFamily="34" charset="0"/>
                </a:rPr>
                <a:t>Control      5 </a:t>
              </a:r>
              <a:r>
                <a:rPr lang="el-GR" sz="1000" dirty="0">
                  <a:latin typeface="Arial" pitchFamily="34" charset="0"/>
                  <a:cs typeface="Arial" pitchFamily="34" charset="0"/>
                </a:rPr>
                <a:t>μ</a:t>
              </a:r>
              <a:r>
                <a:rPr lang="en-US" sz="1000" dirty="0">
                  <a:latin typeface="Arial" pitchFamily="34" charset="0"/>
                  <a:cs typeface="Arial" pitchFamily="34" charset="0"/>
                </a:rPr>
                <a:t>M BCI   10 </a:t>
              </a:r>
              <a:r>
                <a:rPr lang="el-GR" sz="1000" dirty="0">
                  <a:latin typeface="Arial" pitchFamily="34" charset="0"/>
                  <a:cs typeface="Arial" pitchFamily="34" charset="0"/>
                </a:rPr>
                <a:t>μ</a:t>
              </a:r>
              <a:r>
                <a:rPr lang="en-US" sz="1000" dirty="0">
                  <a:latin typeface="Arial" pitchFamily="34" charset="0"/>
                  <a:cs typeface="Arial" pitchFamily="34" charset="0"/>
                </a:rPr>
                <a:t>M BCI                  </a:t>
              </a:r>
            </a:p>
          </p:txBody>
        </p:sp>
      </p:grpSp>
      <p:pic>
        <p:nvPicPr>
          <p:cNvPr id="2050" name="Picture 2" descr="E:\relative cell number H889-H82 BCI.tif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7069" y="4237985"/>
            <a:ext cx="2488995" cy="17579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TextBox 13"/>
          <p:cNvSpPr txBox="1"/>
          <p:nvPr/>
        </p:nvSpPr>
        <p:spPr>
          <a:xfrm>
            <a:off x="304800" y="433864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04800" y="24384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3285200-7D1B-9A71-67A2-BD2BE2E5B9FA}"/>
              </a:ext>
            </a:extLst>
          </p:cNvPr>
          <p:cNvSpPr txBox="1"/>
          <p:nvPr/>
        </p:nvSpPr>
        <p:spPr>
          <a:xfrm>
            <a:off x="307886" y="374572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C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A9E2CB7-FFF1-884F-AA72-FBCCCAB9DCB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1" y="2895600"/>
            <a:ext cx="2903948" cy="1583327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556B66A-A4B2-7453-430F-C5D1F038452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000" y="632477"/>
            <a:ext cx="2903947" cy="1668081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E99B44AB-2760-F488-6AF5-CC928D9EF5FA}"/>
              </a:ext>
            </a:extLst>
          </p:cNvPr>
          <p:cNvSpPr txBox="1"/>
          <p:nvPr/>
        </p:nvSpPr>
        <p:spPr>
          <a:xfrm>
            <a:off x="3459965" y="43386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D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6FC6255-3345-ABB9-A1C2-A94F328DCF99}"/>
              </a:ext>
            </a:extLst>
          </p:cNvPr>
          <p:cNvSpPr txBox="1"/>
          <p:nvPr/>
        </p:nvSpPr>
        <p:spPr>
          <a:xfrm>
            <a:off x="3459965" y="259126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E</a:t>
            </a:r>
          </a:p>
        </p:txBody>
      </p:sp>
      <p:pic>
        <p:nvPicPr>
          <p:cNvPr id="5" name="Picture 5">
            <a:extLst>
              <a:ext uri="{FF2B5EF4-FFF2-40B4-BE49-F238E27FC236}">
                <a16:creationId xmlns:a16="http://schemas.microsoft.com/office/drawing/2014/main" id="{03023A38-4A12-DBC2-26A3-8945978C74A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7797" y="2590610"/>
            <a:ext cx="2074074" cy="1197771"/>
          </a:xfrm>
          <a:prstGeom prst="rect">
            <a:avLst/>
          </a:prstGeom>
          <a:noFill/>
          <a:ln w="1587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773F395-28DE-8CB6-F577-A8A2B4E61097}"/>
              </a:ext>
            </a:extLst>
          </p:cNvPr>
          <p:cNvSpPr txBox="1"/>
          <p:nvPr/>
        </p:nvSpPr>
        <p:spPr>
          <a:xfrm>
            <a:off x="266700" y="6165415"/>
            <a:ext cx="6324600" cy="178510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3. Pharmacological inhibition and genetic editing of DUSP6. Related to </a:t>
            </a:r>
            <a:r>
              <a:rPr lang="en-US" sz="1000" b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4 and 5</a:t>
            </a:r>
            <a:endParaRPr lang="en-US" sz="10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algn="just"/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.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Inhibition of DUSP6 reduces soft agar growth. Colony formation in soft agar by H889 and H82 cells was assessed in the presence and absence of 5 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μM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10 µM BCI.</a:t>
            </a:r>
            <a:r>
              <a:rPr lang="en-US" sz="10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B.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Quantitation of colony formation assay in </a:t>
            </a:r>
            <a:r>
              <a:rPr lang="en-US" sz="1000" b="1" i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.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ffect of 25 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μM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BCI on H889 and H82 cell number was assessed using 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ellTiter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-Blue. Two experiments with 5 replicates each. 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. 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E. 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roliferation assay in HCC1833 WT and DUSP6 KO. Cells were 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rypsinized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3 technical replicates were counted every 24 h over 4 days. 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.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CC1833 DUSP6 KO cells in early passage before undergoing adaptation. N=1 (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an</a:t>
            </a:r>
            <a:r>
              <a:rPr lang="en-US" sz="1000" dirty="0" err="1">
                <a:solidFill>
                  <a:srgbClr val="2B2319"/>
                </a:solidFill>
                <a:effectLst/>
                <a:latin typeface="ArialMT"/>
              </a:rPr>
              <a:t>±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M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3 technical replicates) 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.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HCC1833 DUSP6 KO cells adapt by increasing the number of passages and progressively recover the WT‘s proliferation rate. N=3 (including the previous early passage replicate and 2 more replicates with a higher number of passages, 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mean</a:t>
            </a:r>
            <a:r>
              <a:rPr lang="en-US" sz="1000" dirty="0" err="1">
                <a:solidFill>
                  <a:srgbClr val="2B2319"/>
                </a:solidFill>
                <a:effectLst/>
                <a:latin typeface="ArialMT"/>
              </a:rPr>
              <a:t>±</a:t>
            </a:r>
            <a:r>
              <a:rPr lang="en-US" sz="10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M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f 3 biological replicates). </a:t>
            </a:r>
            <a:r>
              <a:rPr lang="en-US" sz="10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.</a:t>
            </a:r>
            <a:r>
              <a:rPr lang="en-US" sz="10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WT HCC1833 and early or late passage DUSP6 KO cells were assessed for DUSP6 expression. GAPDH was used as a loading control.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9FFBFC74-5E01-68E7-85FC-8D2C779F2BE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91000" y="4724400"/>
            <a:ext cx="1374944" cy="1238020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74CE6B10-99E3-66E3-673B-AF8CAB629201}"/>
              </a:ext>
            </a:extLst>
          </p:cNvPr>
          <p:cNvSpPr txBox="1"/>
          <p:nvPr/>
        </p:nvSpPr>
        <p:spPr>
          <a:xfrm>
            <a:off x="3505200" y="4552421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itchFamily="34" charset="0"/>
                <a:cs typeface="Arial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3331298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644</TotalTime>
  <Words>767</Words>
  <Application>Microsoft Macintosh PowerPoint</Application>
  <PresentationFormat>On-screen Show (4:3)</PresentationFormat>
  <Paragraphs>11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Arial Narrow</vt:lpstr>
      <vt:lpstr>ArialMT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T Southwestern Medical Cen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UO</dc:creator>
  <cp:lastModifiedBy>Ana Martin Vega</cp:lastModifiedBy>
  <cp:revision>287</cp:revision>
  <cp:lastPrinted>2023-06-12T20:56:09Z</cp:lastPrinted>
  <dcterms:created xsi:type="dcterms:W3CDTF">2015-09-25T12:46:51Z</dcterms:created>
  <dcterms:modified xsi:type="dcterms:W3CDTF">2023-06-13T03:41:11Z</dcterms:modified>
</cp:coreProperties>
</file>